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8F8F8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52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59C8B8-E280-41FE-B2CC-FC638947FC92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4AF07-41E6-44B1-A441-19D8B7D22E6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26039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1CFB74-C236-4564-97A0-DB405C9669B0}" type="datetimeFigureOut">
              <a:rPr lang="en-US" smtClean="0"/>
              <a:pPr/>
              <a:t>4/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C5DD6-A22C-49A1-86EC-FE10CBD5B03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971800" y="53340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</a:rPr>
              <a:t>Additional file</a:t>
            </a:r>
            <a:r>
              <a:rPr lang="en-US" b="1" dirty="0" smtClean="0"/>
              <a:t>  7</a:t>
            </a:r>
            <a:endParaRPr lang="en-US" b="1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806311984"/>
              </p:ext>
            </p:extLst>
          </p:nvPr>
        </p:nvGraphicFramePr>
        <p:xfrm>
          <a:off x="1371600" y="1910955"/>
          <a:ext cx="3962400" cy="1670446"/>
        </p:xfrm>
        <a:graphic>
          <a:graphicData uri="http://schemas.openxmlformats.org/drawingml/2006/table">
            <a:tbl>
              <a:tblPr firstRow="1" firstCol="1" bandRow="1"/>
              <a:tblGrid>
                <a:gridCol w="2172399"/>
                <a:gridCol w="1790001"/>
              </a:tblGrid>
              <a:tr h="333803"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Experiment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b="1" dirty="0">
                          <a:effectLst/>
                          <a:latin typeface="Times New Roman"/>
                          <a:ea typeface="Times New Roman"/>
                        </a:rPr>
                        <a:t>Fold change ± SEM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5934"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</a:rPr>
                        <a:t>Experiment </a:t>
                      </a: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1 (Females)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1.16 ± 0.04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3803"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Experiment 2 (Females)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1.19 ± 0.09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3803"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Experiment 2 (Males)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1.18 ± 0.05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3103"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Experiment 3 (Females)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180340" indent="-180340" algn="just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  <a:tabLst>
                          <a:tab pos="180340" algn="l"/>
                        </a:tabLs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</a:rPr>
                        <a:t>1.14 ± 0.02</a:t>
                      </a:r>
                      <a:endParaRPr lang="en-IN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990600" y="1172290"/>
            <a:ext cx="58674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tabLst>
                <a:tab pos="180975" algn="l"/>
              </a:tabLs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80975" algn="l"/>
              </a:tabLst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ld change of the normalized lipid peaks in the 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 NMR spectrum of CM mice with respect to controls.</a:t>
            </a:r>
            <a:endParaRPr kumimoji="0" lang="en-US" alt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80975" algn="l"/>
              </a:tabLst>
            </a:pPr>
            <a:endParaRPr kumimoji="0" lang="en-US" altLang="en-US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39</TotalTime>
  <Words>60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umita</dc:creator>
  <cp:lastModifiedBy>0002486</cp:lastModifiedBy>
  <cp:revision>65</cp:revision>
  <dcterms:created xsi:type="dcterms:W3CDTF">2013-10-30T11:24:19Z</dcterms:created>
  <dcterms:modified xsi:type="dcterms:W3CDTF">2016-04-05T10:08:07Z</dcterms:modified>
</cp:coreProperties>
</file>